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270" r:id="rId2"/>
  </p:sldIdLst>
  <p:sldSz cx="9144000" cy="5715000" type="screen16x1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45E965-0140-ADE0-DB2C-DDC75760A289}" name="Alessandro Fatatis" initials="AF" userId="S::af39@drexel.edu::5421c82d-accb-43d6-bc52-f8c7455fa968" providerId="AD"/>
  <p188:author id="{0D443DB4-5F58-0368-B600-A387FC99D53C}" name="Dinatale,Anthony" initials="D" userId="S::acd84@drexel.edu::4c6ef405-d2be-481c-925d-4add091459f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C"/>
    <a:srgbClr val="2125FF"/>
    <a:srgbClr val="00B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11"/>
    <p:restoredTop sz="96327"/>
  </p:normalViewPr>
  <p:slideViewPr>
    <p:cSldViewPr snapToGrid="0" snapToObjects="1">
      <p:cViewPr varScale="1">
        <p:scale>
          <a:sx n="148" d="100"/>
          <a:sy n="148" d="100"/>
        </p:scale>
        <p:origin x="704" y="192"/>
      </p:cViewPr>
      <p:guideLst/>
    </p:cSldViewPr>
  </p:slideViewPr>
  <p:notesTextViewPr>
    <p:cViewPr>
      <p:scale>
        <a:sx n="114" d="100"/>
        <a:sy n="114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9FFED5-8238-1442-BCC4-7B81FEB7EF0C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20975" y="857250"/>
            <a:ext cx="37020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518B98-75F2-1243-9ECC-791F8B5F4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885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1pPr>
    <a:lvl2pPr marL="408127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2pPr>
    <a:lvl3pPr marL="81625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3pPr>
    <a:lvl4pPr marL="1224380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4pPr>
    <a:lvl5pPr marL="1632507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5pPr>
    <a:lvl6pPr marL="204063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6pPr>
    <a:lvl7pPr marL="2448761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7pPr>
    <a:lvl8pPr marL="2856889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8pPr>
    <a:lvl9pPr marL="326501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720975" y="857250"/>
            <a:ext cx="3702050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591124-4521-724D-8BFA-E3EDB7838D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6200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935302"/>
            <a:ext cx="6858000" cy="19896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001698"/>
            <a:ext cx="6858000" cy="137980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2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168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04271"/>
            <a:ext cx="1971675" cy="48431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04271"/>
            <a:ext cx="5800725" cy="484319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149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472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424782"/>
            <a:ext cx="7886700" cy="2377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824553"/>
            <a:ext cx="7886700" cy="125015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869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521354"/>
            <a:ext cx="3886200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521354"/>
            <a:ext cx="3886200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905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04271"/>
            <a:ext cx="7886700" cy="11046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400969"/>
            <a:ext cx="3868340" cy="6865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087563"/>
            <a:ext cx="3868340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400969"/>
            <a:ext cx="3887391" cy="6865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087563"/>
            <a:ext cx="3887391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079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656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822855"/>
            <a:ext cx="4629150" cy="406135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488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822855"/>
            <a:ext cx="4629150" cy="406135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302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04271"/>
            <a:ext cx="7886700" cy="11046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521354"/>
            <a:ext cx="7886700" cy="36261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5296959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5296959"/>
            <a:ext cx="30861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5296959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476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31B58EB-5E93-FF40-944C-7DDF4AAC9650}"/>
              </a:ext>
            </a:extLst>
          </p:cNvPr>
          <p:cNvSpPr txBox="1"/>
          <p:nvPr/>
        </p:nvSpPr>
        <p:spPr>
          <a:xfrm>
            <a:off x="196443" y="4734458"/>
            <a:ext cx="8751114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PC3-ML cells transduced with an inducible AR-overexpression construct showed strong mitigation of IL-1</a:t>
            </a:r>
            <a:r>
              <a:rPr lang="en-US" sz="1100" dirty="0"/>
              <a:t>β</a:t>
            </a:r>
            <a:endParaRPr lang="en-US" sz="1100" dirty="0">
              <a:latin typeface="Symbol" pitchFamily="2" charset="2"/>
              <a:cs typeface="Arial" panose="020B0604020202020204" pitchFamily="34" charset="0"/>
            </a:endParaRPr>
          </a:p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pression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secretion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as compared to both wild type, non-transduced cells and transduced cells without doxycycline exposure.</a:t>
            </a:r>
          </a:p>
          <a:p>
            <a:pPr algn="just"/>
            <a:r>
              <a:rPr lang="en-US" sz="1200" b="1" dirty="0"/>
              <a:t>a</a:t>
            </a:r>
            <a:r>
              <a:rPr lang="en-US" sz="1200" dirty="0"/>
              <a:t>.*** </a:t>
            </a:r>
            <a:r>
              <a:rPr lang="en-US" sz="1200" i="1" dirty="0"/>
              <a:t>P</a:t>
            </a:r>
            <a:r>
              <a:rPr lang="en-US" sz="1200" dirty="0"/>
              <a:t>= 0.0002; </a:t>
            </a:r>
            <a:r>
              <a:rPr lang="en-US" sz="1200" b="1" dirty="0"/>
              <a:t>b</a:t>
            </a:r>
            <a:r>
              <a:rPr lang="en-US" sz="1200" dirty="0"/>
              <a:t>.  ** </a:t>
            </a:r>
            <a:r>
              <a:rPr lang="en-US" sz="1200" i="1" dirty="0"/>
              <a:t>P</a:t>
            </a:r>
            <a:r>
              <a:rPr lang="en-US" sz="1200" dirty="0"/>
              <a:t>= 0.0035. One-way </a:t>
            </a:r>
            <a:r>
              <a:rPr lang="en-US" sz="1200" dirty="0" err="1"/>
              <a:t>Anova</a:t>
            </a:r>
            <a:r>
              <a:rPr lang="en-US" sz="1200" dirty="0"/>
              <a:t>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63DC806-9B96-684C-8BEA-E9396568E64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3799"/>
          <a:stretch/>
        </p:blipFill>
        <p:spPr>
          <a:xfrm>
            <a:off x="1281953" y="957745"/>
            <a:ext cx="6580094" cy="237928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3F7D49E-570C-5D4A-99A7-67BF958F649D}"/>
              </a:ext>
            </a:extLst>
          </p:cNvPr>
          <p:cNvSpPr txBox="1"/>
          <p:nvPr/>
        </p:nvSpPr>
        <p:spPr>
          <a:xfrm>
            <a:off x="6786282" y="2518946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212EA19-6F98-4B4E-926E-04E75A41C780}"/>
              </a:ext>
            </a:extLst>
          </p:cNvPr>
          <p:cNvSpPr txBox="1"/>
          <p:nvPr/>
        </p:nvSpPr>
        <p:spPr>
          <a:xfrm>
            <a:off x="3312633" y="2629866"/>
            <a:ext cx="42511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8DA78DE-2F21-844B-8A8D-B3A344C1BD5D}"/>
              </a:ext>
            </a:extLst>
          </p:cNvPr>
          <p:cNvSpPr txBox="1"/>
          <p:nvPr/>
        </p:nvSpPr>
        <p:spPr>
          <a:xfrm>
            <a:off x="1029411" y="8330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A4E2A0-6E80-CF40-90E9-92BCC7A78FD1}"/>
              </a:ext>
            </a:extLst>
          </p:cNvPr>
          <p:cNvSpPr txBox="1"/>
          <p:nvPr/>
        </p:nvSpPr>
        <p:spPr>
          <a:xfrm>
            <a:off x="4439317" y="83304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0D06B4-2C60-236B-224F-10B98FF4C4B5}"/>
              </a:ext>
            </a:extLst>
          </p:cNvPr>
          <p:cNvSpPr txBox="1"/>
          <p:nvPr/>
        </p:nvSpPr>
        <p:spPr>
          <a:xfrm rot="18600000">
            <a:off x="2002859" y="3327651"/>
            <a:ext cx="7312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C43499D-BE72-3945-96DB-670BCE8EF839}"/>
              </a:ext>
            </a:extLst>
          </p:cNvPr>
          <p:cNvSpPr txBox="1"/>
          <p:nvPr/>
        </p:nvSpPr>
        <p:spPr>
          <a:xfrm rot="18600000">
            <a:off x="2589880" y="3327085"/>
            <a:ext cx="70564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RE-AR 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 DOX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7CEF18-38E3-55F9-07CC-85BC61DBD3DF}"/>
              </a:ext>
            </a:extLst>
          </p:cNvPr>
          <p:cNvSpPr txBox="1"/>
          <p:nvPr/>
        </p:nvSpPr>
        <p:spPr>
          <a:xfrm rot="18600000">
            <a:off x="3287704" y="3291839"/>
            <a:ext cx="67037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RE-AR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 DOX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DH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7EC92AF-5C11-276F-D028-2AA65D55ECBD}"/>
              </a:ext>
            </a:extLst>
          </p:cNvPr>
          <p:cNvSpPr txBox="1"/>
          <p:nvPr/>
        </p:nvSpPr>
        <p:spPr>
          <a:xfrm rot="18600000">
            <a:off x="5508059" y="3327650"/>
            <a:ext cx="7312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BA4B66E-145C-6C05-60BF-CA88295B90DE}"/>
              </a:ext>
            </a:extLst>
          </p:cNvPr>
          <p:cNvSpPr txBox="1"/>
          <p:nvPr/>
        </p:nvSpPr>
        <p:spPr>
          <a:xfrm rot="18600000">
            <a:off x="6112713" y="3327084"/>
            <a:ext cx="67037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RE-AR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 DOX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B4E471-C47E-5416-E674-F76F7CF8C889}"/>
              </a:ext>
            </a:extLst>
          </p:cNvPr>
          <p:cNvSpPr txBox="1"/>
          <p:nvPr/>
        </p:nvSpPr>
        <p:spPr>
          <a:xfrm rot="18600000">
            <a:off x="6792904" y="3291838"/>
            <a:ext cx="67037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RE-AR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 DOX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DHT</a:t>
            </a:r>
          </a:p>
        </p:txBody>
      </p:sp>
    </p:spTree>
    <p:extLst>
      <p:ext uri="{BB962C8B-B14F-4D97-AF65-F5344CB8AC3E}">
        <p14:creationId xmlns:p14="http://schemas.microsoft.com/office/powerpoint/2010/main" val="3501299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054</TotalTime>
  <Words>89</Words>
  <Application>Microsoft Macintosh PowerPoint</Application>
  <PresentationFormat>On-screen Show (16:10)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o Fatatis</dc:creator>
  <cp:lastModifiedBy>Alessandro Fatatis</cp:lastModifiedBy>
  <cp:revision>255</cp:revision>
  <dcterms:created xsi:type="dcterms:W3CDTF">2021-08-27T21:58:33Z</dcterms:created>
  <dcterms:modified xsi:type="dcterms:W3CDTF">2022-11-02T10:43:57Z</dcterms:modified>
</cp:coreProperties>
</file>